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629"/>
    <p:restoredTop sz="96327"/>
  </p:normalViewPr>
  <p:slideViewPr>
    <p:cSldViewPr snapToGrid="0">
      <p:cViewPr varScale="1">
        <p:scale>
          <a:sx n="101" d="100"/>
          <a:sy n="101" d="100"/>
        </p:scale>
        <p:origin x="208" y="7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8B6839B-347C-8394-3FD7-132FF3395A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D57E89D-7930-C0F4-D9A8-34EA5A1DA7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653EDBF-E7A0-728A-8786-33D9A9EDF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CADC73-B7F9-9084-DA10-8087F6A47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DD49A6-784A-7282-6570-D2B71D40E2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2185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2919F8-A6BE-995F-3472-B296AC5B90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934919B2-ADD9-91D7-3115-355A51CAF1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8BE6C22-A207-39E2-8937-01D413257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7E273A0-1CE9-1679-9B88-75629383D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D8BBCDB-718A-719C-3E4A-FDFB52F94C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90017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AB9C216-E5DD-DD9A-2AE2-A47FB3B652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4592A48-8908-190B-15ED-6FBED3B386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414AAE-CB59-F97B-035A-F986998C2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A8D51D-2FB2-56BB-534D-FCFFF9E0F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5CD1B5-5F44-93D7-D75D-C01FC071A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2286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D2D9EA-4A0D-FB22-DDE2-2FF1160788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F4C6141-748F-C3A6-59A6-DC4D6F452B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16D178-A687-4180-84D0-299F95000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771071B-B689-3D03-B248-C0D9CCD058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9C9B65A-792B-BFD5-0075-D51E0D5E2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91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B368B24-6BFA-EBCA-DE99-63D5384AE8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8623991-9945-38FB-073D-D6352A1092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0C5419-3527-E90B-4695-FFA574680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8C9BB9-FAD2-7FF8-BF89-32AD512EF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5923FC-45FF-33C7-9B71-53650C7B5B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198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9506899-9EFF-D0DA-C8D4-722982EEC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F2A67D0-8860-72FD-3931-DAFB7219865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2A3E0E6-2EE2-9890-5F60-694D8A0D7E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C443102-C472-C8DD-3274-BC070D5D73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47B8C48-6D92-0237-015C-24E821CC9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0F89CC-E22C-0033-7DFA-821921BEE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855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C4ED3D3-682A-5172-F4F2-920CA8E8B7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A41F166-3424-8343-40EE-D6116AFAE9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E0B2984-8987-49C3-0AB1-2886076A6BB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8471449B-8889-E48F-CB60-3C6BDFF7F9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85345B1-6BA0-D1ED-21BD-E3D44F707B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E65A526-AF6B-EA56-2B4D-9FE7DEA57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91765E1-F048-E5B3-7142-633D7D4F2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8E99B5D-252A-951A-109B-4582F3F13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30093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EB6CDB-5BD3-57A9-6755-48975784EA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D102557-15C3-6A1C-2EAA-28BE88954F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46793EC-612B-3966-A5CE-C700B0CD7A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589B557-2BCF-5801-AF3E-F845E33F6D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436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3DC22E5-A913-A958-01D6-E47CF3D90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7F73A06-61C6-A01E-DF38-A151E828D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C8E6207-9875-C1EC-82EB-AB734F24DC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998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BCC83F-FADD-1AF1-A0C5-6C5BB9840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C0C8C4B-BB80-C3FF-9C96-C0EB345B77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86366D6-6ABD-B68F-A228-38C25760D9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06F1E8A-5AB4-4132-F7D9-9D77FB913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B2B7E67-4B36-B6D6-6A2A-62B37867E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FFC1DDD-13C5-787C-AD2C-9EBE0BB721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459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BFC819-1A52-E66C-3D87-1FC2B0800A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3D61A747-9343-B224-762B-53C8768949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9921BD1-F975-ACE1-3A3C-4ECEF05FC2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63EAFAC-F891-56D7-C9D6-3230FCEBB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9C1F2E4-41E8-99B0-34D8-F5A1800051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17E4BC6-7BD1-AFD0-6152-610272384E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13601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D9F7786-97FD-458C-C1BA-678F401FF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89B657A-6E58-0367-4117-B1310B35D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690CB04-8217-07F3-0AB0-86768CF781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8B485B-B1C5-0943-B336-B6C752EB03F8}" type="datetimeFigureOut">
              <a:rPr kumimoji="1" lang="ja-JP" altLang="en-US" smtClean="0"/>
              <a:t>2023/6/16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482CAA-402D-EDBD-2E7B-4E2EBC67379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3309113-9B62-A32C-6484-A0DB6B6D6BB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986EB-A6CF-1A45-8D0D-082961FDEC6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488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336E904-A7B2-C19C-57B9-AA98D9C03BFB}"/>
              </a:ext>
            </a:extLst>
          </p:cNvPr>
          <p:cNvSpPr txBox="1"/>
          <p:nvPr/>
        </p:nvSpPr>
        <p:spPr>
          <a:xfrm>
            <a:off x="607501" y="4529820"/>
            <a:ext cx="979540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>
                <a:latin typeface="Helvetica" pitchFamily="2" charset="0"/>
              </a:rPr>
              <a:t>Figure S1. Electrophoresis of PCR products using various 1st-primer concentrations, showing gel images with all edges visible. </a:t>
            </a:r>
            <a:r>
              <a:rPr lang="en-US" altLang="ja-JP" sz="1400" dirty="0">
                <a:latin typeface="Helvetica" pitchFamily="2" charset="0"/>
              </a:rPr>
              <a:t>(a) Electrophoresis of PCR products created through simplified one-step PCR with different 1st-primer concentrations in pear ‘</a:t>
            </a:r>
            <a:r>
              <a:rPr lang="en-US" altLang="ja-JP" sz="1400" dirty="0" err="1">
                <a:latin typeface="Helvetica" pitchFamily="2" charset="0"/>
              </a:rPr>
              <a:t>Wasekozo</a:t>
            </a:r>
            <a:r>
              <a:rPr lang="en-US" altLang="ja-JP" sz="1400" dirty="0">
                <a:latin typeface="Helvetica" pitchFamily="2" charset="0"/>
              </a:rPr>
              <a:t>’. The PCR products through two-PCR was aligned to indicate target sizes. The five primer sets including TsuENH101, TsuENH57.mod, PPACS2.mod, Psc07 and Mdchr11.34.modA were used in a single multiplex reaction for each sample. (b) Electrophoresis of PCR products created through simplified one-step PCR with different 1st-primer concentrations in chestnut ‘</a:t>
            </a:r>
            <a:r>
              <a:rPr lang="en-US" altLang="ja-JP" sz="1400" dirty="0" err="1">
                <a:latin typeface="Helvetica" pitchFamily="2" charset="0"/>
              </a:rPr>
              <a:t>Otomune</a:t>
            </a:r>
            <a:r>
              <a:rPr lang="en-US" altLang="ja-JP" sz="1400" dirty="0">
                <a:latin typeface="Helvetica" pitchFamily="2" charset="0"/>
              </a:rPr>
              <a:t>’. The two primer sets including CCR1.0F5617761 and CmSca06716 were used in a single multiplex reaction for each sample. </a:t>
            </a:r>
            <a:r>
              <a:rPr lang="en-US" altLang="ja-JP" sz="1400" dirty="0">
                <a:solidFill>
                  <a:srgbClr val="000000"/>
                </a:solidFill>
                <a:effectLst/>
                <a:latin typeface="Helvetica Neue" panose="02000503000000020004" pitchFamily="2" charset="0"/>
              </a:rPr>
              <a:t>The images in Fig. S1a and S1b were used to prepare Fig. 2a and 2c, respectively.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BB25AE5E-B192-4368-9446-49070590DA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5019" y="438744"/>
            <a:ext cx="5449337" cy="3233532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32F24C8-6D08-96BA-78F1-9B0D81DFBDB3}"/>
              </a:ext>
            </a:extLst>
          </p:cNvPr>
          <p:cNvSpPr txBox="1"/>
          <p:nvPr/>
        </p:nvSpPr>
        <p:spPr>
          <a:xfrm>
            <a:off x="2101302" y="3659576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1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0F02BF7-6A0B-6581-ED17-2CAFC5C7D618}"/>
              </a:ext>
            </a:extLst>
          </p:cNvPr>
          <p:cNvSpPr txBox="1"/>
          <p:nvPr/>
        </p:nvSpPr>
        <p:spPr>
          <a:xfrm>
            <a:off x="2337522" y="365957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6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D89B107-0FDC-D30D-0458-901844A9DA80}"/>
              </a:ext>
            </a:extLst>
          </p:cNvPr>
          <p:cNvSpPr txBox="1"/>
          <p:nvPr/>
        </p:nvSpPr>
        <p:spPr>
          <a:xfrm>
            <a:off x="2653282" y="365957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4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D7F46D5-0797-BC96-D1D3-30096B18D54D}"/>
              </a:ext>
            </a:extLst>
          </p:cNvPr>
          <p:cNvSpPr txBox="1"/>
          <p:nvPr/>
        </p:nvSpPr>
        <p:spPr>
          <a:xfrm>
            <a:off x="2939004" y="365957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2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0B86128-69D3-9DB3-CD66-571BC5D0F5FA}"/>
              </a:ext>
            </a:extLst>
          </p:cNvPr>
          <p:cNvSpPr txBox="1"/>
          <p:nvPr/>
        </p:nvSpPr>
        <p:spPr>
          <a:xfrm>
            <a:off x="3236117" y="365957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1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00351ED-429A-5EA5-1E69-78675D09C9C7}"/>
              </a:ext>
            </a:extLst>
          </p:cNvPr>
          <p:cNvSpPr txBox="1"/>
          <p:nvPr/>
        </p:nvSpPr>
        <p:spPr>
          <a:xfrm>
            <a:off x="3512057" y="365957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05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1612915-BF27-07A6-F940-F5DC199F45EB}"/>
              </a:ext>
            </a:extLst>
          </p:cNvPr>
          <p:cNvSpPr txBox="1"/>
          <p:nvPr/>
        </p:nvSpPr>
        <p:spPr>
          <a:xfrm>
            <a:off x="3847238" y="365957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01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58C95C3-2FDF-6869-4174-7D9589ED7615}"/>
              </a:ext>
            </a:extLst>
          </p:cNvPr>
          <p:cNvSpPr txBox="1"/>
          <p:nvPr/>
        </p:nvSpPr>
        <p:spPr>
          <a:xfrm>
            <a:off x="4230925" y="365957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B35F7AC-4F1E-CB23-67E6-99415620BCED}"/>
              </a:ext>
            </a:extLst>
          </p:cNvPr>
          <p:cNvSpPr txBox="1"/>
          <p:nvPr/>
        </p:nvSpPr>
        <p:spPr>
          <a:xfrm>
            <a:off x="2402395" y="3866300"/>
            <a:ext cx="1795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1</a:t>
            </a:r>
            <a:r>
              <a:rPr kumimoji="1" lang="en-US" altLang="ja-JP" sz="900" baseline="30000" dirty="0">
                <a:latin typeface="Helvetica" pitchFamily="2" charset="0"/>
              </a:rPr>
              <a:t>st</a:t>
            </a:r>
            <a:r>
              <a:rPr kumimoji="1" lang="en-US" altLang="ja-JP" sz="900" dirty="0">
                <a:latin typeface="Helvetica" pitchFamily="2" charset="0"/>
              </a:rPr>
              <a:t> primer concentration (</a:t>
            </a:r>
            <a:r>
              <a:rPr kumimoji="1" lang="en-US" altLang="ja-JP" sz="900" dirty="0" err="1">
                <a:latin typeface="Helvetica" pitchFamily="2" charset="0"/>
              </a:rPr>
              <a:t>μM</a:t>
            </a:r>
            <a:r>
              <a:rPr kumimoji="1" lang="en-US" altLang="ja-JP" sz="900" dirty="0">
                <a:latin typeface="Helvetica" pitchFamily="2" charset="0"/>
              </a:rPr>
              <a:t>) of</a:t>
            </a:r>
            <a:br>
              <a:rPr kumimoji="1" lang="en-US" altLang="ja-JP" sz="900" dirty="0">
                <a:latin typeface="Helvetica" pitchFamily="2" charset="0"/>
              </a:rPr>
            </a:br>
            <a:r>
              <a:rPr kumimoji="1" lang="en-US" altLang="ja-JP" sz="900" dirty="0">
                <a:latin typeface="Helvetica" pitchFamily="2" charset="0"/>
              </a:rPr>
              <a:t>simplified one-step PCR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F37569D1-DAEE-26C8-903F-F469FBA1FDF5}"/>
              </a:ext>
            </a:extLst>
          </p:cNvPr>
          <p:cNvCxnSpPr>
            <a:cxnSpLocks/>
          </p:cNvCxnSpPr>
          <p:nvPr/>
        </p:nvCxnSpPr>
        <p:spPr>
          <a:xfrm>
            <a:off x="2178467" y="3899250"/>
            <a:ext cx="23012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4F292C6-FD7F-DCE3-EEC4-BF5BBA5D49B8}"/>
              </a:ext>
            </a:extLst>
          </p:cNvPr>
          <p:cNvSpPr txBox="1"/>
          <p:nvPr/>
        </p:nvSpPr>
        <p:spPr>
          <a:xfrm>
            <a:off x="4445896" y="385970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Two-step</a:t>
            </a:r>
          </a:p>
          <a:p>
            <a:r>
              <a:rPr kumimoji="1" lang="en-US" altLang="ja-JP" sz="900" dirty="0">
                <a:latin typeface="Helvetica" pitchFamily="2" charset="0"/>
              </a:rPr>
              <a:t>PCR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A8B39CB-1A2B-43B8-B990-5C2786E81336}"/>
              </a:ext>
            </a:extLst>
          </p:cNvPr>
          <p:cNvSpPr txBox="1"/>
          <p:nvPr/>
        </p:nvSpPr>
        <p:spPr>
          <a:xfrm>
            <a:off x="7769486" y="3672276"/>
            <a:ext cx="3449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1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85A63AC-A72F-A3CF-10F6-323A391F1B30}"/>
              </a:ext>
            </a:extLst>
          </p:cNvPr>
          <p:cNvSpPr txBox="1"/>
          <p:nvPr/>
        </p:nvSpPr>
        <p:spPr>
          <a:xfrm>
            <a:off x="8005706" y="367227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6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AED3233-5D82-A08C-2735-F9714E4F534C}"/>
              </a:ext>
            </a:extLst>
          </p:cNvPr>
          <p:cNvSpPr txBox="1"/>
          <p:nvPr/>
        </p:nvSpPr>
        <p:spPr>
          <a:xfrm>
            <a:off x="8321466" y="367227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4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1023858-4613-ADD5-A87A-403CCDBF02CB}"/>
              </a:ext>
            </a:extLst>
          </p:cNvPr>
          <p:cNvSpPr txBox="1"/>
          <p:nvPr/>
        </p:nvSpPr>
        <p:spPr>
          <a:xfrm>
            <a:off x="8607188" y="367227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2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9CE8388-9158-692B-2F22-6221ACA52BBA}"/>
              </a:ext>
            </a:extLst>
          </p:cNvPr>
          <p:cNvSpPr txBox="1"/>
          <p:nvPr/>
        </p:nvSpPr>
        <p:spPr>
          <a:xfrm>
            <a:off x="8904301" y="3672276"/>
            <a:ext cx="4090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1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09367C2-6A13-A914-77D7-C3AAE701BFCC}"/>
              </a:ext>
            </a:extLst>
          </p:cNvPr>
          <p:cNvSpPr txBox="1"/>
          <p:nvPr/>
        </p:nvSpPr>
        <p:spPr>
          <a:xfrm>
            <a:off x="9180241" y="367227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05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1744A0A-BFA9-710C-9D05-890638F8D5AB}"/>
              </a:ext>
            </a:extLst>
          </p:cNvPr>
          <p:cNvSpPr txBox="1"/>
          <p:nvPr/>
        </p:nvSpPr>
        <p:spPr>
          <a:xfrm>
            <a:off x="9515422" y="3672276"/>
            <a:ext cx="4732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.001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71DE00C-18AC-C350-0B5F-18BDCF393E70}"/>
              </a:ext>
            </a:extLst>
          </p:cNvPr>
          <p:cNvSpPr txBox="1"/>
          <p:nvPr/>
        </p:nvSpPr>
        <p:spPr>
          <a:xfrm>
            <a:off x="9899109" y="3672276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900" dirty="0">
                <a:latin typeface="Helvetica" pitchFamily="2" charset="0"/>
              </a:rPr>
              <a:t>0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2A3A7D0-D1E9-B3C0-5764-DCA0216F0795}"/>
              </a:ext>
            </a:extLst>
          </p:cNvPr>
          <p:cNvSpPr txBox="1"/>
          <p:nvPr/>
        </p:nvSpPr>
        <p:spPr>
          <a:xfrm>
            <a:off x="8070579" y="3879000"/>
            <a:ext cx="17956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1</a:t>
            </a:r>
            <a:r>
              <a:rPr kumimoji="1" lang="en-US" altLang="ja-JP" sz="900" baseline="30000" dirty="0">
                <a:latin typeface="Helvetica" pitchFamily="2" charset="0"/>
              </a:rPr>
              <a:t>st</a:t>
            </a:r>
            <a:r>
              <a:rPr kumimoji="1" lang="en-US" altLang="ja-JP" sz="900" dirty="0">
                <a:latin typeface="Helvetica" pitchFamily="2" charset="0"/>
              </a:rPr>
              <a:t> primer concentration (</a:t>
            </a:r>
            <a:r>
              <a:rPr kumimoji="1" lang="en-US" altLang="ja-JP" sz="900" dirty="0" err="1">
                <a:latin typeface="Helvetica" pitchFamily="2" charset="0"/>
              </a:rPr>
              <a:t>μM</a:t>
            </a:r>
            <a:r>
              <a:rPr kumimoji="1" lang="en-US" altLang="ja-JP" sz="900" dirty="0">
                <a:latin typeface="Helvetica" pitchFamily="2" charset="0"/>
              </a:rPr>
              <a:t>) of</a:t>
            </a:r>
            <a:br>
              <a:rPr kumimoji="1" lang="en-US" altLang="ja-JP" sz="900" dirty="0">
                <a:latin typeface="Helvetica" pitchFamily="2" charset="0"/>
              </a:rPr>
            </a:br>
            <a:r>
              <a:rPr kumimoji="1" lang="en-US" altLang="ja-JP" sz="900" dirty="0">
                <a:latin typeface="Helvetica" pitchFamily="2" charset="0"/>
              </a:rPr>
              <a:t>simplified one-step PCR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0C81EA2-CBB5-6704-CFA1-60A32C76A082}"/>
              </a:ext>
            </a:extLst>
          </p:cNvPr>
          <p:cNvCxnSpPr>
            <a:cxnSpLocks/>
          </p:cNvCxnSpPr>
          <p:nvPr/>
        </p:nvCxnSpPr>
        <p:spPr>
          <a:xfrm>
            <a:off x="7846651" y="3911950"/>
            <a:ext cx="23012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AA2EDAB-103C-FA2C-06FB-03795A9436F1}"/>
              </a:ext>
            </a:extLst>
          </p:cNvPr>
          <p:cNvSpPr txBox="1"/>
          <p:nvPr/>
        </p:nvSpPr>
        <p:spPr>
          <a:xfrm>
            <a:off x="10114080" y="3872404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Two-step</a:t>
            </a:r>
          </a:p>
          <a:p>
            <a:r>
              <a:rPr kumimoji="1" lang="en-US" altLang="ja-JP" sz="900" dirty="0">
                <a:latin typeface="Helvetica" pitchFamily="2" charset="0"/>
              </a:rPr>
              <a:t>PCR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7FB19999-1C29-D28E-F7D2-68463FCF3D93}"/>
              </a:ext>
            </a:extLst>
          </p:cNvPr>
          <p:cNvCxnSpPr>
            <a:cxnSpLocks/>
          </p:cNvCxnSpPr>
          <p:nvPr/>
        </p:nvCxnSpPr>
        <p:spPr>
          <a:xfrm>
            <a:off x="6576750" y="2517914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94059E66-46EA-11D4-171E-719D75EF0827}"/>
              </a:ext>
            </a:extLst>
          </p:cNvPr>
          <p:cNvSpPr txBox="1"/>
          <p:nvPr/>
        </p:nvSpPr>
        <p:spPr>
          <a:xfrm>
            <a:off x="6279456" y="2405820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200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21A23EE-243E-E877-2C31-03171AF89A98}"/>
              </a:ext>
            </a:extLst>
          </p:cNvPr>
          <p:cNvSpPr txBox="1"/>
          <p:nvPr/>
        </p:nvSpPr>
        <p:spPr>
          <a:xfrm>
            <a:off x="6279456" y="2009291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400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AFC1C9DC-BBF2-137A-4BA8-3884F9CB9F99}"/>
              </a:ext>
            </a:extLst>
          </p:cNvPr>
          <p:cNvCxnSpPr>
            <a:cxnSpLocks/>
          </p:cNvCxnSpPr>
          <p:nvPr/>
        </p:nvCxnSpPr>
        <p:spPr>
          <a:xfrm>
            <a:off x="6576750" y="2133592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5876CC94-BA70-4C70-E063-6360887CAE22}"/>
              </a:ext>
            </a:extLst>
          </p:cNvPr>
          <p:cNvSpPr txBox="1"/>
          <p:nvPr/>
        </p:nvSpPr>
        <p:spPr>
          <a:xfrm>
            <a:off x="6279456" y="1785635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600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F5A1AE90-F347-0BAE-8170-88852AD9BDA9}"/>
              </a:ext>
            </a:extLst>
          </p:cNvPr>
          <p:cNvCxnSpPr>
            <a:cxnSpLocks/>
          </p:cNvCxnSpPr>
          <p:nvPr/>
        </p:nvCxnSpPr>
        <p:spPr>
          <a:xfrm>
            <a:off x="6576750" y="1901652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D8586BE5-42F4-6A64-4DC6-648CCEBC610B}"/>
              </a:ext>
            </a:extLst>
          </p:cNvPr>
          <p:cNvCxnSpPr>
            <a:cxnSpLocks/>
          </p:cNvCxnSpPr>
          <p:nvPr/>
        </p:nvCxnSpPr>
        <p:spPr>
          <a:xfrm>
            <a:off x="6576750" y="1731411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C0878280-0639-46C7-E6E1-1003F9784178}"/>
              </a:ext>
            </a:extLst>
          </p:cNvPr>
          <p:cNvCxnSpPr>
            <a:cxnSpLocks/>
          </p:cNvCxnSpPr>
          <p:nvPr/>
        </p:nvCxnSpPr>
        <p:spPr>
          <a:xfrm>
            <a:off x="6576750" y="1626022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F14CCEC2-CB74-22A9-4129-AB8E5E32CEFF}"/>
              </a:ext>
            </a:extLst>
          </p:cNvPr>
          <p:cNvSpPr txBox="1"/>
          <p:nvPr/>
        </p:nvSpPr>
        <p:spPr>
          <a:xfrm>
            <a:off x="6279456" y="1614733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800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8AED19B9-3C06-34F9-F34F-3EA2B2B73F58}"/>
              </a:ext>
            </a:extLst>
          </p:cNvPr>
          <p:cNvSpPr txBox="1"/>
          <p:nvPr/>
        </p:nvSpPr>
        <p:spPr>
          <a:xfrm>
            <a:off x="6213995" y="149531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1000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75541DE6-4CAB-A27F-DE3A-A0F939792F25}"/>
              </a:ext>
            </a:extLst>
          </p:cNvPr>
          <p:cNvSpPr txBox="1"/>
          <p:nvPr/>
        </p:nvSpPr>
        <p:spPr>
          <a:xfrm>
            <a:off x="6279456" y="2554143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(bp)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3AA947F6-A224-2E16-B854-1713DC25EA27}"/>
              </a:ext>
            </a:extLst>
          </p:cNvPr>
          <p:cNvCxnSpPr>
            <a:cxnSpLocks/>
          </p:cNvCxnSpPr>
          <p:nvPr/>
        </p:nvCxnSpPr>
        <p:spPr>
          <a:xfrm>
            <a:off x="578454" y="2567291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273E9E03-6836-CEC5-1CBE-26C58E22FE79}"/>
              </a:ext>
            </a:extLst>
          </p:cNvPr>
          <p:cNvSpPr txBox="1"/>
          <p:nvPr/>
        </p:nvSpPr>
        <p:spPr>
          <a:xfrm>
            <a:off x="281160" y="2455197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200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011F5B99-94DC-E20F-54B5-CBE600ED1A9E}"/>
              </a:ext>
            </a:extLst>
          </p:cNvPr>
          <p:cNvSpPr txBox="1"/>
          <p:nvPr/>
        </p:nvSpPr>
        <p:spPr>
          <a:xfrm>
            <a:off x="281160" y="2062534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400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FAB63169-CBEA-4B8C-827D-280FDB21A26A}"/>
              </a:ext>
            </a:extLst>
          </p:cNvPr>
          <p:cNvCxnSpPr>
            <a:cxnSpLocks/>
          </p:cNvCxnSpPr>
          <p:nvPr/>
        </p:nvCxnSpPr>
        <p:spPr>
          <a:xfrm>
            <a:off x="578454" y="2186835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152F0D2-0025-D5C2-0CED-28F9696DC9E7}"/>
              </a:ext>
            </a:extLst>
          </p:cNvPr>
          <p:cNvSpPr txBox="1"/>
          <p:nvPr/>
        </p:nvSpPr>
        <p:spPr>
          <a:xfrm>
            <a:off x="281160" y="182452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600</a:t>
            </a:r>
            <a:endParaRPr kumimoji="1" lang="ja-JP" altLang="en-US" sz="900">
              <a:latin typeface="Helvetica" pitchFamily="2" charset="0"/>
            </a:endParaRPr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07366CED-909D-667C-C742-52033B8A1896}"/>
              </a:ext>
            </a:extLst>
          </p:cNvPr>
          <p:cNvCxnSpPr>
            <a:cxnSpLocks/>
          </p:cNvCxnSpPr>
          <p:nvPr/>
        </p:nvCxnSpPr>
        <p:spPr>
          <a:xfrm>
            <a:off x="578454" y="1940539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316EB9A7-C505-1C10-A240-1E61EEDF0AAA}"/>
              </a:ext>
            </a:extLst>
          </p:cNvPr>
          <p:cNvCxnSpPr>
            <a:cxnSpLocks/>
          </p:cNvCxnSpPr>
          <p:nvPr/>
        </p:nvCxnSpPr>
        <p:spPr>
          <a:xfrm>
            <a:off x="578454" y="1763120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線コネクタ 55">
            <a:extLst>
              <a:ext uri="{FF2B5EF4-FFF2-40B4-BE49-F238E27FC236}">
                <a16:creationId xmlns:a16="http://schemas.microsoft.com/office/drawing/2014/main" id="{57AADAEB-8621-30E9-114B-A5F462FED89F}"/>
              </a:ext>
            </a:extLst>
          </p:cNvPr>
          <p:cNvCxnSpPr>
            <a:cxnSpLocks/>
          </p:cNvCxnSpPr>
          <p:nvPr/>
        </p:nvCxnSpPr>
        <p:spPr>
          <a:xfrm>
            <a:off x="578454" y="1657731"/>
            <a:ext cx="10889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6B8396F1-094A-277B-6AE7-FC7A297CFDD9}"/>
              </a:ext>
            </a:extLst>
          </p:cNvPr>
          <p:cNvSpPr txBox="1"/>
          <p:nvPr/>
        </p:nvSpPr>
        <p:spPr>
          <a:xfrm>
            <a:off x="281160" y="1646442"/>
            <a:ext cx="3770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800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B12CAA30-0E87-C0A8-599B-4AD68B1DA587}"/>
              </a:ext>
            </a:extLst>
          </p:cNvPr>
          <p:cNvSpPr txBox="1"/>
          <p:nvPr/>
        </p:nvSpPr>
        <p:spPr>
          <a:xfrm>
            <a:off x="215699" y="1527027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1000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E0CB2EE1-E8A7-E3A2-13D6-EDF4AD7A24B1}"/>
              </a:ext>
            </a:extLst>
          </p:cNvPr>
          <p:cNvSpPr txBox="1"/>
          <p:nvPr/>
        </p:nvSpPr>
        <p:spPr>
          <a:xfrm>
            <a:off x="281160" y="2603520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(bp)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940869D4-BAA7-F035-AD70-AC11C2EC4C41}"/>
              </a:ext>
            </a:extLst>
          </p:cNvPr>
          <p:cNvSpPr txBox="1"/>
          <p:nvPr/>
        </p:nvSpPr>
        <p:spPr>
          <a:xfrm>
            <a:off x="67644" y="100652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dirty="0">
                <a:latin typeface="Helvetica" pitchFamily="2" charset="0"/>
              </a:rPr>
              <a:t>(a)</a:t>
            </a:r>
            <a:endParaRPr kumimoji="1" lang="ja-JP" altLang="en-US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C307C718-0106-52BE-E0B8-5408F6447AFF}"/>
              </a:ext>
            </a:extLst>
          </p:cNvPr>
          <p:cNvSpPr txBox="1"/>
          <p:nvPr/>
        </p:nvSpPr>
        <p:spPr>
          <a:xfrm>
            <a:off x="6218850" y="99229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" altLang="ja-JP" dirty="0">
                <a:latin typeface="Helvetica" pitchFamily="2" charset="0"/>
              </a:rPr>
              <a:t>(b)</a:t>
            </a:r>
            <a:endParaRPr kumimoji="1" lang="ja-JP" altLang="en-US"/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id="{B729CF83-956C-DCF5-28A1-2CFBF68808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1046" y="407244"/>
            <a:ext cx="5424601" cy="32405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766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208</Words>
  <Application>Microsoft Macintosh PowerPoint</Application>
  <PresentationFormat>ワイド画面</PresentationFormat>
  <Paragraphs>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Helvetica</vt:lpstr>
      <vt:lpstr>Helvetica Neu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西尾　聡悟</dc:creator>
  <cp:lastModifiedBy>西尾　聡悟</cp:lastModifiedBy>
  <cp:revision>8</cp:revision>
  <dcterms:created xsi:type="dcterms:W3CDTF">2023-06-07T05:55:12Z</dcterms:created>
  <dcterms:modified xsi:type="dcterms:W3CDTF">2023-06-16T08:45:43Z</dcterms:modified>
</cp:coreProperties>
</file>